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80" r:id="rId3"/>
    <p:sldId id="279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631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417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8517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8615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5051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2580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2885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228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1212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977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7004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323227-7FE4-4569-B196-9FE98EF5E695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6E2B8B-0CD3-41FD-A5C9-5A17D3103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6449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641987" y="2196025"/>
            <a:ext cx="9144000" cy="1655762"/>
          </a:xfrm>
        </p:spPr>
        <p:txBody>
          <a:bodyPr/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9 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3659335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085942" y="5830524"/>
            <a:ext cx="87364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A9-1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even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’expression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volved in N assimilation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71797" y="762630"/>
            <a:ext cx="3829669" cy="3857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38209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/>
          <p:cNvSpPr txBox="1"/>
          <p:nvPr/>
        </p:nvSpPr>
        <p:spPr>
          <a:xfrm>
            <a:off x="132213" y="5855396"/>
            <a:ext cx="858590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9-2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welv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involved in N assimilation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endParaRPr lang="en-US" altLang="zh-CN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28038" y="200460"/>
            <a:ext cx="3974136" cy="65782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73346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56</TotalTime>
  <Words>19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Presentation</vt:lpstr>
      <vt:lpstr>PowerPoint Presentation</vt:lpstr>
      <vt:lpstr>PowerPoint Presentation</vt:lpstr>
    </vt:vector>
  </TitlesOfParts>
  <Company>HZAU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o Hua</dc:creator>
  <cp:lastModifiedBy>MDPI</cp:lastModifiedBy>
  <cp:revision>54</cp:revision>
  <dcterms:created xsi:type="dcterms:W3CDTF">2020-01-05T03:20:41Z</dcterms:created>
  <dcterms:modified xsi:type="dcterms:W3CDTF">2020-09-17T03:46:49Z</dcterms:modified>
</cp:coreProperties>
</file>